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6479540" cy="791972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6" userDrawn="1">
          <p15:clr>
            <a:srgbClr val="A4A3A4"/>
          </p15:clr>
        </p15:guide>
        <p15:guide id="2" pos="20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356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000" y="1296167"/>
            <a:ext cx="4860000" cy="2757333"/>
          </a:xfrm>
        </p:spPr>
        <p:txBody>
          <a:bodyPr anchor="b"/>
          <a:lstStyle>
            <a:lvl1pPr algn="ctr">
              <a:defRPr sz="425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0000" y="4159834"/>
            <a:ext cx="4860000" cy="1912166"/>
          </a:xfrm>
        </p:spPr>
        <p:txBody>
          <a:bodyPr/>
          <a:lstStyle>
            <a:lvl1pPr marL="0" indent="0" algn="ctr">
              <a:buNone/>
              <a:defRPr sz="1700"/>
            </a:lvl1pPr>
            <a:lvl2pPr marL="323850" indent="0" algn="ctr">
              <a:buNone/>
              <a:defRPr sz="1415"/>
            </a:lvl2pPr>
            <a:lvl3pPr marL="647700" indent="0" algn="ctr">
              <a:buNone/>
              <a:defRPr sz="1275"/>
            </a:lvl3pPr>
            <a:lvl4pPr marL="972185" indent="0" algn="ctr">
              <a:buNone/>
              <a:defRPr sz="1135"/>
            </a:lvl4pPr>
            <a:lvl5pPr marL="1296035" indent="0" algn="ctr">
              <a:buNone/>
              <a:defRPr sz="1135"/>
            </a:lvl5pPr>
            <a:lvl6pPr marL="1619885" indent="0" algn="ctr">
              <a:buNone/>
              <a:defRPr sz="1135"/>
            </a:lvl6pPr>
            <a:lvl7pPr marL="1943735" indent="0" algn="ctr">
              <a:buNone/>
              <a:defRPr sz="1135"/>
            </a:lvl7pPr>
            <a:lvl8pPr marL="2268220" indent="0" algn="ctr">
              <a:buNone/>
              <a:defRPr sz="1135"/>
            </a:lvl8pPr>
            <a:lvl9pPr marL="2592070" indent="0" algn="ctr">
              <a:buNone/>
              <a:defRPr sz="1135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37250" y="421667"/>
            <a:ext cx="1397250" cy="671183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45500" y="421667"/>
            <a:ext cx="4110750" cy="671183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2125" y="1974501"/>
            <a:ext cx="5589000" cy="3294500"/>
          </a:xfrm>
        </p:spPr>
        <p:txBody>
          <a:bodyPr anchor="b"/>
          <a:lstStyle>
            <a:lvl1pPr>
              <a:defRPr sz="425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2125" y="5300167"/>
            <a:ext cx="5589000" cy="1732499"/>
          </a:xfrm>
        </p:spPr>
        <p:txBody>
          <a:bodyPr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23850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2pPr>
            <a:lvl3pPr marL="647700" indent="0">
              <a:buNone/>
              <a:defRPr sz="1275">
                <a:solidFill>
                  <a:schemeClr val="tx1">
                    <a:tint val="75000"/>
                  </a:schemeClr>
                </a:solidFill>
              </a:defRPr>
            </a:lvl3pPr>
            <a:lvl4pPr marL="97218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4pPr>
            <a:lvl5pPr marL="129603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5pPr>
            <a:lvl6pPr marL="161988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6pPr>
            <a:lvl7pPr marL="194373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7pPr>
            <a:lvl8pPr marL="2268220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8pPr>
            <a:lvl9pPr marL="2592070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45500" y="2108333"/>
            <a:ext cx="2754000" cy="502516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80500" y="2108333"/>
            <a:ext cx="2754000" cy="502516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421667"/>
            <a:ext cx="5589000" cy="153083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6344" y="1941501"/>
            <a:ext cx="2741344" cy="951499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3850" indent="0">
              <a:buNone/>
              <a:defRPr sz="1415" b="1"/>
            </a:lvl2pPr>
            <a:lvl3pPr marL="647700" indent="0">
              <a:buNone/>
              <a:defRPr sz="1275" b="1"/>
            </a:lvl3pPr>
            <a:lvl4pPr marL="972185" indent="0">
              <a:buNone/>
              <a:defRPr sz="1135" b="1"/>
            </a:lvl4pPr>
            <a:lvl5pPr marL="1296035" indent="0">
              <a:buNone/>
              <a:defRPr sz="1135" b="1"/>
            </a:lvl5pPr>
            <a:lvl6pPr marL="1619885" indent="0">
              <a:buNone/>
              <a:defRPr sz="1135" b="1"/>
            </a:lvl6pPr>
            <a:lvl7pPr marL="1943735" indent="0">
              <a:buNone/>
              <a:defRPr sz="1135" b="1"/>
            </a:lvl7pPr>
            <a:lvl8pPr marL="2268220" indent="0">
              <a:buNone/>
              <a:defRPr sz="1135" b="1"/>
            </a:lvl8pPr>
            <a:lvl9pPr marL="2592070" indent="0">
              <a:buNone/>
              <a:defRPr sz="113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46344" y="2893000"/>
            <a:ext cx="2741344" cy="425516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280500" y="1941501"/>
            <a:ext cx="2754844" cy="951499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3850" indent="0">
              <a:buNone/>
              <a:defRPr sz="1415" b="1"/>
            </a:lvl2pPr>
            <a:lvl3pPr marL="647700" indent="0">
              <a:buNone/>
              <a:defRPr sz="1275" b="1"/>
            </a:lvl3pPr>
            <a:lvl4pPr marL="972185" indent="0">
              <a:buNone/>
              <a:defRPr sz="1135" b="1"/>
            </a:lvl4pPr>
            <a:lvl5pPr marL="1296035" indent="0">
              <a:buNone/>
              <a:defRPr sz="1135" b="1"/>
            </a:lvl5pPr>
            <a:lvl6pPr marL="1619885" indent="0">
              <a:buNone/>
              <a:defRPr sz="1135" b="1"/>
            </a:lvl6pPr>
            <a:lvl7pPr marL="1943735" indent="0">
              <a:buNone/>
              <a:defRPr sz="1135" b="1"/>
            </a:lvl7pPr>
            <a:lvl8pPr marL="2268220" indent="0">
              <a:buNone/>
              <a:defRPr sz="1135" b="1"/>
            </a:lvl8pPr>
            <a:lvl9pPr marL="2592070" indent="0">
              <a:buNone/>
              <a:defRPr sz="113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280500" y="2893000"/>
            <a:ext cx="2754844" cy="425516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528000"/>
            <a:ext cx="2089969" cy="1848000"/>
          </a:xfrm>
        </p:spPr>
        <p:txBody>
          <a:bodyPr anchor="b"/>
          <a:lstStyle>
            <a:lvl1pPr>
              <a:defRPr sz="227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754844" y="1140333"/>
            <a:ext cx="3280500" cy="5628334"/>
          </a:xfrm>
        </p:spPr>
        <p:txBody>
          <a:bodyPr/>
          <a:lstStyle>
            <a:lvl1pPr>
              <a:defRPr sz="2270"/>
            </a:lvl1pPr>
            <a:lvl2pPr>
              <a:defRPr sz="1985"/>
            </a:lvl2pPr>
            <a:lvl3pPr>
              <a:defRPr sz="1700"/>
            </a:lvl3pPr>
            <a:lvl4pPr>
              <a:defRPr sz="1415"/>
            </a:lvl4pPr>
            <a:lvl5pPr>
              <a:defRPr sz="1415"/>
            </a:lvl5pPr>
            <a:lvl6pPr>
              <a:defRPr sz="1415"/>
            </a:lvl6pPr>
            <a:lvl7pPr>
              <a:defRPr sz="1415"/>
            </a:lvl7pPr>
            <a:lvl8pPr>
              <a:defRPr sz="1415"/>
            </a:lvl8pPr>
            <a:lvl9pPr>
              <a:defRPr sz="141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46344" y="2376000"/>
            <a:ext cx="2089969" cy="4401834"/>
          </a:xfrm>
        </p:spPr>
        <p:txBody>
          <a:bodyPr/>
          <a:lstStyle>
            <a:lvl1pPr marL="0" indent="0">
              <a:buNone/>
              <a:defRPr sz="1135"/>
            </a:lvl1pPr>
            <a:lvl2pPr marL="323850" indent="0">
              <a:buNone/>
              <a:defRPr sz="990"/>
            </a:lvl2pPr>
            <a:lvl3pPr marL="647700" indent="0">
              <a:buNone/>
              <a:defRPr sz="850"/>
            </a:lvl3pPr>
            <a:lvl4pPr marL="972185" indent="0">
              <a:buNone/>
              <a:defRPr sz="710"/>
            </a:lvl4pPr>
            <a:lvl5pPr marL="1296035" indent="0">
              <a:buNone/>
              <a:defRPr sz="710"/>
            </a:lvl5pPr>
            <a:lvl6pPr marL="1619885" indent="0">
              <a:buNone/>
              <a:defRPr sz="710"/>
            </a:lvl6pPr>
            <a:lvl7pPr marL="1943735" indent="0">
              <a:buNone/>
              <a:defRPr sz="710"/>
            </a:lvl7pPr>
            <a:lvl8pPr marL="2268220" indent="0">
              <a:buNone/>
              <a:defRPr sz="710"/>
            </a:lvl8pPr>
            <a:lvl9pPr marL="2592070" indent="0">
              <a:buNone/>
              <a:defRPr sz="71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528000"/>
            <a:ext cx="2089969" cy="1848000"/>
          </a:xfrm>
        </p:spPr>
        <p:txBody>
          <a:bodyPr anchor="b"/>
          <a:lstStyle>
            <a:lvl1pPr>
              <a:defRPr sz="227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754844" y="1140333"/>
            <a:ext cx="3280500" cy="5628334"/>
          </a:xfrm>
        </p:spPr>
        <p:txBody>
          <a:bodyPr/>
          <a:lstStyle>
            <a:lvl1pPr marL="0" indent="0">
              <a:buNone/>
              <a:defRPr sz="2270"/>
            </a:lvl1pPr>
            <a:lvl2pPr marL="323850" indent="0">
              <a:buNone/>
              <a:defRPr sz="1985"/>
            </a:lvl2pPr>
            <a:lvl3pPr marL="647700" indent="0">
              <a:buNone/>
              <a:defRPr sz="1700"/>
            </a:lvl3pPr>
            <a:lvl4pPr marL="972185" indent="0">
              <a:buNone/>
              <a:defRPr sz="1415"/>
            </a:lvl4pPr>
            <a:lvl5pPr marL="1296035" indent="0">
              <a:buNone/>
              <a:defRPr sz="1415"/>
            </a:lvl5pPr>
            <a:lvl6pPr marL="1619885" indent="0">
              <a:buNone/>
              <a:defRPr sz="1415"/>
            </a:lvl6pPr>
            <a:lvl7pPr marL="1943735" indent="0">
              <a:buNone/>
              <a:defRPr sz="1415"/>
            </a:lvl7pPr>
            <a:lvl8pPr marL="2268220" indent="0">
              <a:buNone/>
              <a:defRPr sz="1415"/>
            </a:lvl8pPr>
            <a:lvl9pPr marL="2592070" indent="0">
              <a:buNone/>
              <a:defRPr sz="141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46344" y="2376000"/>
            <a:ext cx="2089969" cy="4401834"/>
          </a:xfrm>
        </p:spPr>
        <p:txBody>
          <a:bodyPr/>
          <a:lstStyle>
            <a:lvl1pPr marL="0" indent="0">
              <a:buNone/>
              <a:defRPr sz="1135"/>
            </a:lvl1pPr>
            <a:lvl2pPr marL="323850" indent="0">
              <a:buNone/>
              <a:defRPr sz="990"/>
            </a:lvl2pPr>
            <a:lvl3pPr marL="647700" indent="0">
              <a:buNone/>
              <a:defRPr sz="850"/>
            </a:lvl3pPr>
            <a:lvl4pPr marL="972185" indent="0">
              <a:buNone/>
              <a:defRPr sz="710"/>
            </a:lvl4pPr>
            <a:lvl5pPr marL="1296035" indent="0">
              <a:buNone/>
              <a:defRPr sz="710"/>
            </a:lvl5pPr>
            <a:lvl6pPr marL="1619885" indent="0">
              <a:buNone/>
              <a:defRPr sz="710"/>
            </a:lvl6pPr>
            <a:lvl7pPr marL="1943735" indent="0">
              <a:buNone/>
              <a:defRPr sz="710"/>
            </a:lvl7pPr>
            <a:lvl8pPr marL="2268220" indent="0">
              <a:buNone/>
              <a:defRPr sz="710"/>
            </a:lvl8pPr>
            <a:lvl9pPr marL="2592070" indent="0">
              <a:buNone/>
              <a:defRPr sz="71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45500" y="421667"/>
            <a:ext cx="5589000" cy="15308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5500" y="2108333"/>
            <a:ext cx="5589000" cy="50251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45500" y="7340667"/>
            <a:ext cx="1458000" cy="421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146500" y="7340667"/>
            <a:ext cx="2187000" cy="421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576500" y="7340667"/>
            <a:ext cx="1458000" cy="421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47700" rtl="0" eaLnBrk="1" latinLnBrk="0" hangingPunct="1">
        <a:lnSpc>
          <a:spcPct val="90000"/>
        </a:lnSpc>
        <a:spcBef>
          <a:spcPct val="0"/>
        </a:spcBef>
        <a:buNone/>
        <a:defRPr sz="31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1925" indent="-161925" algn="l" defTabSz="647700" rtl="0" eaLnBrk="1" latinLnBrk="0" hangingPunct="1">
        <a:lnSpc>
          <a:spcPct val="90000"/>
        </a:lnSpc>
        <a:spcBef>
          <a:spcPct val="142000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1pPr>
      <a:lvl2pPr marL="48577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1026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4pPr>
      <a:lvl5pPr marL="145796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5pPr>
      <a:lvl6pPr marL="178181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6pPr>
      <a:lvl7pPr marL="210629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7pPr>
      <a:lvl8pPr marL="243014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8pPr>
      <a:lvl9pPr marL="275399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1pPr>
      <a:lvl2pPr marL="32385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2pPr>
      <a:lvl3pPr marL="64770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97218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4pPr>
      <a:lvl5pPr marL="129603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5pPr>
      <a:lvl6pPr marL="161988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6pPr>
      <a:lvl7pPr marL="194373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7pPr>
      <a:lvl8pPr marL="226822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8pPr>
      <a:lvl9pPr marL="259207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150495" y="-86360"/>
            <a:ext cx="1625600" cy="45231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ref        : NEFDFE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QLC37129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JU57273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KP20000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KP19996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UKT59874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55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43352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CH92678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UYG25652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43292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CJ06245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54694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QV08602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54714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54844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53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J92406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54754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54864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KP19995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QV08592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L54764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AN74569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QMI58105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56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JU57363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UKT59869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pPr algn="l">
              <a:buClrTx/>
              <a:buSzTx/>
              <a:buNone/>
            </a:pP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QKI37668.1 : ..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42290" y="5715"/>
            <a:ext cx="804545" cy="2527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AHSV-1</a:t>
            </a:r>
            <a:endParaRPr lang="en-US" altLang="zh-CN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42290" y="4573270"/>
            <a:ext cx="804545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AHSV-2</a:t>
            </a:r>
            <a:endParaRPr lang="en-US" altLang="zh-CN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743710" y="-131445"/>
            <a:ext cx="1387475" cy="302704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ref        : NEFDFE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64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63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62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293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YG25672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66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IX10311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KB92755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BI96880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HZ12846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YG25762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20026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A10628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413.1 : H.I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Q89508.1   : H.I.V.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055495" y="2517775"/>
            <a:ext cx="804545" cy="2425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AHSV-4</a:t>
            </a:r>
            <a:endParaRPr lang="en-US" altLang="zh-CN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354705" y="-86360"/>
            <a:ext cx="1642110" cy="25844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ref        : NEFDFE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844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9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4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5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HZ12848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90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433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2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7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313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AN74571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845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ZQ19576.1 : TQ..P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6.1 : TQ..PD  :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705860" y="5715"/>
            <a:ext cx="804545" cy="2578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AHSV-5</a:t>
            </a:r>
            <a:endParaRPr lang="en-US" altLang="zh-CN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380105" y="2271395"/>
            <a:ext cx="1660525" cy="341503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ref        : NEFDFE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BI96882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100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103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91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94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102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97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93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092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M00101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IX10308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KP19874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HI44018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UZQ19616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KP19876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JU57393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LG63774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UYG25702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HZ12849.1 : AQ...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AJU57323.1 : AQ...G</a:t>
            </a:r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: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705860" y="2351405"/>
            <a:ext cx="804545" cy="260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AHSV-6</a:t>
            </a:r>
            <a:endParaRPr lang="en-US" altLang="zh-CN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946015" y="1925320"/>
            <a:ext cx="1344295" cy="355600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ref        : NEFDFE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ZQ19566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813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IX10305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IX10304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120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ZQ19606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811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YG25692.1 : T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BI96883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343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373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118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ZQ19596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115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110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812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810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G63794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116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YG25722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HI44020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KB92745.1 : QQ..PD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KB92805.1 : QQ..PD :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306695" y="2017395"/>
            <a:ext cx="8045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AHSV-8</a:t>
            </a:r>
            <a:endParaRPr lang="en-US" altLang="zh-CN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220345" y="47625"/>
            <a:ext cx="1188085" cy="4194175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218440" y="4615180"/>
            <a:ext cx="1188085" cy="1824990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5011420" y="2073910"/>
            <a:ext cx="1188085" cy="3517900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1783080" y="2552065"/>
            <a:ext cx="1188085" cy="4761865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6" name="组合 5"/>
          <p:cNvGrpSpPr/>
          <p:nvPr/>
        </p:nvGrpSpPr>
        <p:grpSpPr>
          <a:xfrm>
            <a:off x="1784985" y="5715"/>
            <a:ext cx="1187450" cy="2385695"/>
            <a:chOff x="2811" y="9"/>
            <a:chExt cx="1870" cy="3757"/>
          </a:xfrm>
        </p:grpSpPr>
        <p:sp>
          <p:nvSpPr>
            <p:cNvPr id="9" name="文本框 8"/>
            <p:cNvSpPr txBox="1"/>
            <p:nvPr/>
          </p:nvSpPr>
          <p:spPr>
            <a:xfrm>
              <a:off x="3237" y="9"/>
              <a:ext cx="1267" cy="3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000">
                  <a:latin typeface="Times New Roman" panose="02020603050405020304" charset="0"/>
                  <a:cs typeface="Times New Roman" panose="02020603050405020304" charset="0"/>
                </a:rPr>
                <a:t>AHSV-3</a:t>
              </a:r>
              <a:endParaRPr lang="en-US" altLang="zh-CN" sz="10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>
              <a:off x="2811" y="72"/>
              <a:ext cx="1871" cy="3694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34" name="矩形 33"/>
          <p:cNvSpPr/>
          <p:nvPr/>
        </p:nvSpPr>
        <p:spPr>
          <a:xfrm>
            <a:off x="3426460" y="20955"/>
            <a:ext cx="1188085" cy="2303780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5" name="矩形 34"/>
          <p:cNvSpPr/>
          <p:nvPr/>
        </p:nvSpPr>
        <p:spPr>
          <a:xfrm>
            <a:off x="3437890" y="2380615"/>
            <a:ext cx="1188085" cy="3112135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10" name="组合 9"/>
          <p:cNvGrpSpPr/>
          <p:nvPr/>
        </p:nvGrpSpPr>
        <p:grpSpPr>
          <a:xfrm>
            <a:off x="4936490" y="-117475"/>
            <a:ext cx="1501140" cy="2306320"/>
            <a:chOff x="12628" y="4380"/>
            <a:chExt cx="2364" cy="3632"/>
          </a:xfrm>
        </p:grpSpPr>
        <p:sp>
          <p:nvSpPr>
            <p:cNvPr id="16" name="文本框 15"/>
            <p:cNvSpPr txBox="1"/>
            <p:nvPr/>
          </p:nvSpPr>
          <p:spPr>
            <a:xfrm>
              <a:off x="12628" y="4380"/>
              <a:ext cx="2364" cy="363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                       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                       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ref        : NEFDFE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UYG25712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07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KP19925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05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JU57333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06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KP19924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04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HI44019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AN74570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HZ12850.1 : S...VD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JU57403.1 : S...VD : 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                      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3181" y="4538"/>
              <a:ext cx="1267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Times New Roman" panose="02020603050405020304" charset="0"/>
                  <a:cs typeface="Times New Roman" panose="02020603050405020304" charset="0"/>
                </a:rPr>
                <a:t>AHSV-7</a:t>
              </a:r>
              <a:endParaRPr lang="en-US" altLang="zh-CN" sz="10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>
              <a:off x="12747" y="4619"/>
              <a:ext cx="1871" cy="3116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4971415" y="5526405"/>
            <a:ext cx="1395730" cy="2029460"/>
            <a:chOff x="7829" y="5535"/>
            <a:chExt cx="2198" cy="3196"/>
          </a:xfrm>
        </p:grpSpPr>
        <p:sp>
          <p:nvSpPr>
            <p:cNvPr id="20" name="文本框 19"/>
            <p:cNvSpPr txBox="1"/>
            <p:nvPr/>
          </p:nvSpPr>
          <p:spPr>
            <a:xfrm>
              <a:off x="7829" y="5535"/>
              <a:ext cx="2198" cy="319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                       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                       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ref</a:t>
              </a:r>
              <a:r>
                <a:rPr lang="en-US" altLang="zh-CN" sz="900">
                  <a:latin typeface="宋体" panose="02010600030101010101" pitchFamily="2" charset="-122"/>
                  <a:ea typeface="宋体" panose="02010600030101010101" pitchFamily="2" charset="-122"/>
                </a:rPr>
                <a:t> </a:t>
              </a:r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       : NEFDFE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IX10306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IX10307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29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21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23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24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25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26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ALM00127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UZQ19626.1 : R...I.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r>
                <a:rPr lang="zh-CN" altLang="en-US" sz="900">
                  <a:latin typeface="宋体" panose="02010600030101010101" pitchFamily="2" charset="-122"/>
                  <a:ea typeface="宋体" panose="02010600030101010101" pitchFamily="2" charset="-122"/>
                </a:rPr>
                <a:t>                       </a:t>
              </a:r>
              <a:endParaRPr lang="zh-CN" altLang="en-US" sz="900"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8357" y="5690"/>
              <a:ext cx="1267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Times New Roman" panose="02020603050405020304" charset="0"/>
                  <a:cs typeface="Times New Roman" panose="02020603050405020304" charset="0"/>
                </a:rPr>
                <a:t>AHSV-9</a:t>
              </a:r>
              <a:endParaRPr lang="en-US" altLang="zh-CN" sz="10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>
              <a:off x="7913" y="5748"/>
              <a:ext cx="1871" cy="2749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163830" y="4450715"/>
            <a:ext cx="1539875" cy="20300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ref        : NEFDFE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IX10301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HI44017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G63764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60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CI41991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YG25662.1 : QQ..A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57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20046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58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AN74572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59.1 : QQ..V.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737995" y="2128520"/>
            <a:ext cx="1381125" cy="53543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ref        : NEFDFE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73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765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75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0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FK24717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303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J92416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72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19764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F23183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P32553.2  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L54824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81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IX10302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74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20094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KP39978.1 : F..EYD AIX10303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71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AA42537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78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LT60733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JU57423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BW21096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IX10313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LM00070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YG25682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UYG25772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BAA05619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BI96881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AA67288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AAA42541.1 : F..EYD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r>
              <a:rPr lang="zh-CN" altLang="en-US" sz="900">
                <a:latin typeface="宋体" panose="02010600030101010101" pitchFamily="2" charset="-122"/>
                <a:ea typeface="宋体" panose="02010600030101010101" pitchFamily="2" charset="-122"/>
              </a:rPr>
              <a:t>                                                                                  </a:t>
            </a:r>
            <a:endParaRPr lang="zh-CN" altLang="en-US" sz="90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11125" y="7426960"/>
            <a:ext cx="6181725" cy="3149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Fig S1.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Analysis of the conservation of the </a:t>
            </a:r>
            <a:r>
              <a:rPr lang="zh-CN" altLang="en-US" sz="1200" baseline="30000">
                <a:latin typeface="Times New Roman" panose="02020603050405020304" charset="0"/>
                <a:cs typeface="Times New Roman" panose="02020603050405020304" charset="0"/>
              </a:rPr>
              <a:t>670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NEFDFE</a:t>
            </a:r>
            <a:r>
              <a:rPr lang="zh-CN" altLang="en-US" sz="1200" baseline="30000">
                <a:latin typeface="Times New Roman" panose="02020603050405020304" charset="0"/>
                <a:cs typeface="Times New Roman" panose="02020603050405020304" charset="0"/>
              </a:rPr>
              <a:t>675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 epitope in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nine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serotypes of AHSV.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The dots indicate residues identical to the reference sequence (ref)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zY0MTQ3OTllODcxMDJhNDhiOWUyYmI1MTAzMjk2MmE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59</Words>
  <Application>WPS 演示</Application>
  <PresentationFormat>宽屏</PresentationFormat>
  <Paragraphs>2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uefeng</dc:creator>
  <cp:lastModifiedBy>XF</cp:lastModifiedBy>
  <cp:revision>14</cp:revision>
  <dcterms:created xsi:type="dcterms:W3CDTF">2023-08-09T12:44:00Z</dcterms:created>
  <dcterms:modified xsi:type="dcterms:W3CDTF">2024-11-06T08:32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59965734C1243CC8496B809693D1BFD_13</vt:lpwstr>
  </property>
  <property fmtid="{D5CDD505-2E9C-101B-9397-08002B2CF9AE}" pid="3" name="KSOProductBuildVer">
    <vt:lpwstr>2052-12.1.0.18608</vt:lpwstr>
  </property>
</Properties>
</file>